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2" r:id="rId3"/>
    <p:sldId id="264" r:id="rId4"/>
    <p:sldId id="266" r:id="rId5"/>
    <p:sldId id="263" r:id="rId6"/>
  </p:sldIdLst>
  <p:sldSz cx="12192000" cy="6858000"/>
  <p:notesSz cx="6858000" cy="9144000"/>
  <p:defaultTextStyle>
    <a:defPPr>
      <a:defRPr lang="en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D5B7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18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24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77F385-4B8C-4542-8AA5-F07BF3522F7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NL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2020565-C534-4F65-855E-E9F74560359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3E7EA5-EA66-459E-B268-9F8ACB0D09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38E5C-6DCB-4FAB-AD2C-0631D768CFED}" type="datetimeFigureOut">
              <a:rPr lang="en-NL" smtClean="0"/>
              <a:t>29/03/2022</a:t>
            </a:fld>
            <a:endParaRPr lang="en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073A58-D156-47CF-BF36-8C6CEA2F89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E4DCEF-5790-4E93-9BC3-7C40D4A815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F601-65AD-4CE1-B78F-5BF462AA6534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27379851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67F569-4C79-46F2-BFFE-500028BC63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5AAB655-E54A-4CEE-AC95-70C97A21A1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B38517-3D2F-45B0-BA62-8EB261F36F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38E5C-6DCB-4FAB-AD2C-0631D768CFED}" type="datetimeFigureOut">
              <a:rPr lang="en-NL" smtClean="0"/>
              <a:t>29/03/2022</a:t>
            </a:fld>
            <a:endParaRPr lang="en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2C4436-BE04-4B9B-A22B-0E5DDD9E7B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D7E9A6-77EB-42AC-AA5D-9BA54E49EB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F601-65AD-4CE1-B78F-5BF462AA6534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25372593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CF82941-DDCE-4C73-BCBC-B4B0584090B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N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E1A5621-3156-4BBD-BB55-87433246586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132CC3-93B0-48C2-801B-C5AF9A0C57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38E5C-6DCB-4FAB-AD2C-0631D768CFED}" type="datetimeFigureOut">
              <a:rPr lang="en-NL" smtClean="0"/>
              <a:t>29/03/2022</a:t>
            </a:fld>
            <a:endParaRPr lang="en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AD9B90-57BB-44AA-BC1D-FCD343AF06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404353-EE83-4E2F-9603-CCD30A8449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F601-65AD-4CE1-B78F-5BF462AA6534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4085001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105E2B-9B41-43E0-B87B-6DF749661B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A4CCC0D-DF99-49B7-83BE-3069A6383D1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8D994F-2011-42B0-BD39-B73B310CF2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38E5C-6DCB-4FAB-AD2C-0631D768CFED}" type="datetimeFigureOut">
              <a:rPr lang="en-NL" smtClean="0"/>
              <a:t>29/03/2022</a:t>
            </a:fld>
            <a:endParaRPr lang="en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AF7989-EF66-4C1F-B95A-22792EADDB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224F9F-BF32-4C89-BC1F-DBEACEF324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F601-65AD-4CE1-B78F-5BF462AA6534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3809158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1B2A53-3DAE-43CC-9226-C038B76295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N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B84FD06-224E-44EE-9E26-F5E9BCA931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7606BB-97B2-4817-902E-DD6C76DF18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38E5C-6DCB-4FAB-AD2C-0631D768CFED}" type="datetimeFigureOut">
              <a:rPr lang="en-NL" smtClean="0"/>
              <a:t>29/03/2022</a:t>
            </a:fld>
            <a:endParaRPr lang="en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BA164A-C7F3-4C02-977C-C17DB963E8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CBE29F-A1A0-416D-8352-040470BE94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F601-65AD-4CE1-B78F-5BF462AA6534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25445870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1080F3-8913-4CF6-AA65-D60F9E9DCE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76E208-B8EE-48D6-B038-DD08E72F479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L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EAA7BFD-AD01-43DF-95A2-DA2675490F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L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1629F0D-FDAB-4FBF-AB8D-C49C68ACE6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38E5C-6DCB-4FAB-AD2C-0631D768CFED}" type="datetimeFigureOut">
              <a:rPr lang="en-NL" smtClean="0"/>
              <a:t>29/03/2022</a:t>
            </a:fld>
            <a:endParaRPr lang="en-N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DE047FD-EF6F-4C6C-8451-11F4CC9E47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71E8691-F565-4B77-B58D-C74B2CEE02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F601-65AD-4CE1-B78F-5BF462AA6534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28160807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0D9381-7921-48D8-9217-168722C0B8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N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82F23CF-7D16-40EB-AB41-CDD2B0A165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8BE1D0C-13BC-4223-B574-6A0EE704D80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L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AF7662C-CCFF-4CCF-B431-A8E46436F3B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441CABF-C9BF-46A2-B3DF-244530F2077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L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1E0DF6B-D933-406C-A55E-49233F4FB8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38E5C-6DCB-4FAB-AD2C-0631D768CFED}" type="datetimeFigureOut">
              <a:rPr lang="en-NL" smtClean="0"/>
              <a:t>29/03/2022</a:t>
            </a:fld>
            <a:endParaRPr lang="en-NL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23ADDE2-AA80-49AB-9223-B397F715BC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736F975-3127-46CF-9353-BA46760568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F601-65AD-4CE1-B78F-5BF462AA6534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26060795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87C08A-C6EE-4E28-BBC7-915791D7AC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L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5ED434B-3177-4E32-8AB5-133B92AFDE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38E5C-6DCB-4FAB-AD2C-0631D768CFED}" type="datetimeFigureOut">
              <a:rPr lang="en-NL" smtClean="0"/>
              <a:t>29/03/2022</a:t>
            </a:fld>
            <a:endParaRPr lang="en-NL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1474B7D-E006-485F-A687-BFACE0C05D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EE55C7C-8494-4A3A-A6C1-A9BAD0E584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F601-65AD-4CE1-B78F-5BF462AA6534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21240434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84F89C3-BCB1-4949-B61E-3AA71D9D80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38E5C-6DCB-4FAB-AD2C-0631D768CFED}" type="datetimeFigureOut">
              <a:rPr lang="en-NL" smtClean="0"/>
              <a:t>29/03/2022</a:t>
            </a:fld>
            <a:endParaRPr lang="en-NL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B3D364D-E757-4100-B695-5BBD0CEB86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939DE93-85FA-4F3D-9F12-9C29E5346F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F601-65AD-4CE1-B78F-5BF462AA6534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20601796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48E2BC-A0E6-4C98-90FC-FEE99EA614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N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E2E8B6-CEEA-4340-8331-E266ADC087B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D8EC527-D540-46FC-97B2-6B1F16DD68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39B729-68ED-410A-99C5-EA4C4A3E9A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38E5C-6DCB-4FAB-AD2C-0631D768CFED}" type="datetimeFigureOut">
              <a:rPr lang="en-NL" smtClean="0"/>
              <a:t>29/03/2022</a:t>
            </a:fld>
            <a:endParaRPr lang="en-N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36C7C22-6A6B-47E5-BF6E-7D196289E7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740FD23-22EF-4BDC-9E5A-CB601DFFE1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F601-65AD-4CE1-B78F-5BF462AA6534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163597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DE2FE4-2956-4B7C-B465-DBB23DCBD7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NL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3A4F055-C8C6-450A-9EFE-610A782888C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N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A5FF061-9C08-432D-A453-771D656754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1AD4C5C-54EF-45C7-8E3B-E205FDFC85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38E5C-6DCB-4FAB-AD2C-0631D768CFED}" type="datetimeFigureOut">
              <a:rPr lang="en-NL" smtClean="0"/>
              <a:t>29/03/2022</a:t>
            </a:fld>
            <a:endParaRPr lang="en-N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2DC84FA-B649-4048-9008-96C554C8E6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799572C-DDC7-466D-A1FD-E6CE248EC7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0EF601-65AD-4CE1-B78F-5BF462AA6534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4483395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DBB582D-21AB-4309-8F42-26343AEA33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N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EB46AF-1072-446D-955D-D570DDB4F4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24A629-C44B-4104-844E-8C278425F26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138E5C-6DCB-4FAB-AD2C-0631D768CFED}" type="datetimeFigureOut">
              <a:rPr lang="en-NL" smtClean="0"/>
              <a:t>29/03/2022</a:t>
            </a:fld>
            <a:endParaRPr lang="en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F9E7EF-6319-4B41-9B86-A708F4D63D9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5F3E4D-430E-49C5-933D-6B37EA70643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0EF601-65AD-4CE1-B78F-5BF462AA6534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9597465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"/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0E2BFBF-9031-4066-B96F-98DE4A348870}"/>
              </a:ext>
            </a:extLst>
          </p:cNvPr>
          <p:cNvSpPr txBox="1"/>
          <p:nvPr/>
        </p:nvSpPr>
        <p:spPr>
          <a:xfrm>
            <a:off x="955221" y="293914"/>
            <a:ext cx="34453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/>
              <a:t>Supplementary figure 1</a:t>
            </a:r>
            <a:endParaRPr lang="en-NL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8034C01-8388-4B5C-BF85-1A6ACB170EC0}"/>
              </a:ext>
            </a:extLst>
          </p:cNvPr>
          <p:cNvSpPr txBox="1"/>
          <p:nvPr/>
        </p:nvSpPr>
        <p:spPr>
          <a:xfrm>
            <a:off x="1511166" y="1145406"/>
            <a:ext cx="2406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NL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E6FC7DD-ECDB-4F8E-9906-A9BEAEFDC643}"/>
              </a:ext>
            </a:extLst>
          </p:cNvPr>
          <p:cNvSpPr txBox="1"/>
          <p:nvPr/>
        </p:nvSpPr>
        <p:spPr>
          <a:xfrm>
            <a:off x="1511166" y="2623900"/>
            <a:ext cx="2406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NL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0FE3DDD2-FE3F-4B65-A74C-F7BFDAD86D4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1798" y="827723"/>
            <a:ext cx="8534400" cy="15240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874EAE45-4F2D-4292-9497-319DF65714A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98682" y="3043436"/>
            <a:ext cx="3896336" cy="1000098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FC47D806-B3F0-43C1-A9CB-7EDBFF990ED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1500" y="2623900"/>
            <a:ext cx="4017182" cy="183917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6010D77D-91AB-4319-9FDC-FFC14DD9D7D1}"/>
              </a:ext>
            </a:extLst>
          </p:cNvPr>
          <p:cNvSpPr txBox="1"/>
          <p:nvPr/>
        </p:nvSpPr>
        <p:spPr>
          <a:xfrm>
            <a:off x="5778366" y="2623900"/>
            <a:ext cx="2406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NL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DF1F737-EA3E-4531-8406-EBEA892845F9}"/>
              </a:ext>
            </a:extLst>
          </p:cNvPr>
          <p:cNvSpPr txBox="1"/>
          <p:nvPr/>
        </p:nvSpPr>
        <p:spPr>
          <a:xfrm>
            <a:off x="587829" y="4519958"/>
            <a:ext cx="9323615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>
                <a:latin typeface="Arial" panose="020B0604020202020204" pitchFamily="34" charset="0"/>
                <a:cs typeface="Arial" panose="020B0604020202020204" pitchFamily="34" charset="0"/>
              </a:rPr>
              <a:t>Supplementary figure 1: </a:t>
            </a:r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DELs observed in mCRC</a:t>
            </a:r>
          </a:p>
          <a:p>
            <a:r>
              <a:rPr lang="en-US" sz="11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 Genome wide density plot of DELs. Horizontal red line indicate at least 150 events, selecting 13 hotspot regions. </a:t>
            </a:r>
            <a:r>
              <a:rPr lang="en-US" sz="11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100">
                <a:latin typeface="Arial" panose="020B0604020202020204" pitchFamily="34" charset="0"/>
                <a:cs typeface="Arial" panose="020B0604020202020204" pitchFamily="34" charset="0"/>
              </a:rPr>
              <a:t> Overview of a single metastatic biopsy of a patient, showing multiple and overlapping DELs in </a:t>
            </a:r>
            <a:r>
              <a:rPr lang="en-GB" sz="1100" i="1">
                <a:latin typeface="Arial" panose="020B0604020202020204" pitchFamily="34" charset="0"/>
                <a:cs typeface="Arial" panose="020B0604020202020204" pitchFamily="34" charset="0"/>
              </a:rPr>
              <a:t>MACROD2</a:t>
            </a:r>
            <a:r>
              <a:rPr lang="en-GB" sz="110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10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1100">
                <a:latin typeface="Arial" panose="020B0604020202020204" pitchFamily="34" charset="0"/>
                <a:cs typeface="Arial" panose="020B0604020202020204" pitchFamily="34" charset="0"/>
              </a:rPr>
              <a:t> Sequence logo of the DNA sequence surrounding the breakpoints of DELs inside a CFS. Nucleotide nr 21 is the breakpoint location, and the relative height of the letters correspond to the frequency of the nucleotides at that location.</a:t>
            </a:r>
            <a:endParaRPr lang="en-NL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814616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4765ADB-5F97-41D0-87C2-A6BE6907CEE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8791" y="892625"/>
            <a:ext cx="8534417" cy="441960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5AA48D7C-F9E1-41D8-B08F-9CE1057C40FB}"/>
              </a:ext>
            </a:extLst>
          </p:cNvPr>
          <p:cNvSpPr txBox="1"/>
          <p:nvPr/>
        </p:nvSpPr>
        <p:spPr>
          <a:xfrm>
            <a:off x="955221" y="293914"/>
            <a:ext cx="69804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/>
              <a:t>Supplementary figure 2</a:t>
            </a:r>
            <a:endParaRPr lang="en-NL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B6193E9-F6FC-425A-89B3-7FF155B6067C}"/>
              </a:ext>
            </a:extLst>
          </p:cNvPr>
          <p:cNvSpPr txBox="1"/>
          <p:nvPr/>
        </p:nvSpPr>
        <p:spPr>
          <a:xfrm>
            <a:off x="1118507" y="2686051"/>
            <a:ext cx="8164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/>
              <a:t>Dup</a:t>
            </a:r>
          </a:p>
        </p:txBody>
      </p:sp>
      <p:sp>
        <p:nvSpPr>
          <p:cNvPr id="6" name="Left Brace 5">
            <a:extLst>
              <a:ext uri="{FF2B5EF4-FFF2-40B4-BE49-F238E27FC236}">
                <a16:creationId xmlns:a16="http://schemas.microsoft.com/office/drawing/2014/main" id="{034994EF-1CF7-42C5-9EAA-53C99661A184}"/>
              </a:ext>
            </a:extLst>
          </p:cNvPr>
          <p:cNvSpPr/>
          <p:nvPr/>
        </p:nvSpPr>
        <p:spPr>
          <a:xfrm>
            <a:off x="1616529" y="1461409"/>
            <a:ext cx="212262" cy="2833007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NL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1628054-87B3-4443-B9B7-9B3DD0E4EA07}"/>
              </a:ext>
            </a:extLst>
          </p:cNvPr>
          <p:cNvSpPr txBox="1"/>
          <p:nvPr/>
        </p:nvSpPr>
        <p:spPr>
          <a:xfrm>
            <a:off x="612322" y="5678353"/>
            <a:ext cx="932361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>
                <a:latin typeface="Arial" panose="020B0604020202020204" pitchFamily="34" charset="0"/>
                <a:cs typeface="Arial" panose="020B0604020202020204" pitchFamily="34" charset="0"/>
              </a:rPr>
              <a:t>Supplementary figure 2: </a:t>
            </a:r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position and size of duplications in mCRC</a:t>
            </a:r>
          </a:p>
          <a:p>
            <a:r>
              <a:rPr lang="en-GB" sz="1100">
                <a:latin typeface="Arial" panose="020B0604020202020204" pitchFamily="34" charset="0"/>
                <a:cs typeface="Arial" panose="020B0604020202020204" pitchFamily="34" charset="0"/>
              </a:rPr>
              <a:t>Density plots of DUPs by the indicated sizes across the genome. Each track is scaled to the maximum density within that track.</a:t>
            </a:r>
            <a:endParaRPr lang="en-NL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645105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1CFE4CD-D133-4556-B728-79A4EEFDC787}"/>
              </a:ext>
            </a:extLst>
          </p:cNvPr>
          <p:cNvSpPr txBox="1"/>
          <p:nvPr/>
        </p:nvSpPr>
        <p:spPr>
          <a:xfrm>
            <a:off x="955221" y="293914"/>
            <a:ext cx="86673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/>
              <a:t>Supplementary figure 3</a:t>
            </a:r>
            <a:endParaRPr lang="en-NL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FF139827-C67B-4EE9-8CB7-9343AED1789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9965" y="1472293"/>
            <a:ext cx="5519397" cy="3532414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313E56F4-9E5B-47BB-963D-D6CDBEC95AD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24561" y="1472293"/>
            <a:ext cx="5740173" cy="3532414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A81384A0-F577-412A-BE71-1E1BC541E2C7}"/>
              </a:ext>
            </a:extLst>
          </p:cNvPr>
          <p:cNvSpPr txBox="1"/>
          <p:nvPr/>
        </p:nvSpPr>
        <p:spPr>
          <a:xfrm>
            <a:off x="627084" y="4916347"/>
            <a:ext cx="932361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>
                <a:latin typeface="Arial" panose="020B0604020202020204" pitchFamily="34" charset="0"/>
                <a:cs typeface="Arial" panose="020B0604020202020204" pitchFamily="34" charset="0"/>
              </a:rPr>
              <a:t>Supplementary figure 3: </a:t>
            </a:r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Details of CFS regions without single large gene at center</a:t>
            </a:r>
          </a:p>
          <a:p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Two chromosomal regions showing the locations of genes, Ini-seq peaks, DUPs and DELs between 10kb-1Mb</a:t>
            </a:r>
          </a:p>
        </p:txBody>
      </p:sp>
    </p:spTree>
    <p:extLst>
      <p:ext uri="{BB962C8B-B14F-4D97-AF65-F5344CB8AC3E}">
        <p14:creationId xmlns:p14="http://schemas.microsoft.com/office/powerpoint/2010/main" val="41155055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A3083AC-3722-48E3-B8F1-7D6B0AE91D3E}"/>
              </a:ext>
            </a:extLst>
          </p:cNvPr>
          <p:cNvSpPr txBox="1"/>
          <p:nvPr/>
        </p:nvSpPr>
        <p:spPr>
          <a:xfrm>
            <a:off x="955220" y="293914"/>
            <a:ext cx="55881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/>
              <a:t>Supplementary figure 4</a:t>
            </a:r>
            <a:endParaRPr lang="en-NL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FD933EA1-34AE-4494-80C9-F1D17CF0D64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4954" y="910441"/>
            <a:ext cx="5978460" cy="348938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FB9D17E-FD27-426B-BC6A-04CD32B3808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98642" y="2024709"/>
            <a:ext cx="4496266" cy="2375120"/>
          </a:xfrm>
          <a:prstGeom prst="rect">
            <a:avLst/>
          </a:prstGeom>
        </p:spPr>
      </p:pic>
      <p:sp>
        <p:nvSpPr>
          <p:cNvPr id="7" name="Left Brace 6">
            <a:extLst>
              <a:ext uri="{FF2B5EF4-FFF2-40B4-BE49-F238E27FC236}">
                <a16:creationId xmlns:a16="http://schemas.microsoft.com/office/drawing/2014/main" id="{C017CDF0-BCA7-4E33-B7A5-1807918B88F4}"/>
              </a:ext>
            </a:extLst>
          </p:cNvPr>
          <p:cNvSpPr/>
          <p:nvPr/>
        </p:nvSpPr>
        <p:spPr>
          <a:xfrm>
            <a:off x="1249960" y="2432807"/>
            <a:ext cx="50334" cy="729843"/>
          </a:xfrm>
          <a:prstGeom prst="leftBrace">
            <a:avLst/>
          </a:prstGeom>
          <a:noFill/>
          <a:ln w="28575">
            <a:solidFill>
              <a:srgbClr val="AD5B7A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NL"/>
          </a:p>
        </p:txBody>
      </p:sp>
      <p:sp>
        <p:nvSpPr>
          <p:cNvPr id="8" name="Left Brace 7">
            <a:extLst>
              <a:ext uri="{FF2B5EF4-FFF2-40B4-BE49-F238E27FC236}">
                <a16:creationId xmlns:a16="http://schemas.microsoft.com/office/drawing/2014/main" id="{FD284D23-931F-4BA8-AC0D-E04D420D72C8}"/>
              </a:ext>
            </a:extLst>
          </p:cNvPr>
          <p:cNvSpPr/>
          <p:nvPr/>
        </p:nvSpPr>
        <p:spPr>
          <a:xfrm>
            <a:off x="1732421" y="3265915"/>
            <a:ext cx="50334" cy="360000"/>
          </a:xfrm>
          <a:prstGeom prst="leftBrace">
            <a:avLst/>
          </a:prstGeom>
          <a:noFill/>
          <a:ln w="28575">
            <a:solidFill>
              <a:srgbClr val="AD5B7A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NL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27B6ABC-8BFF-4AD0-9E23-743B255DC503}"/>
              </a:ext>
            </a:extLst>
          </p:cNvPr>
          <p:cNvSpPr txBox="1"/>
          <p:nvPr/>
        </p:nvSpPr>
        <p:spPr>
          <a:xfrm>
            <a:off x="627084" y="4916347"/>
            <a:ext cx="9323615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>
                <a:latin typeface="Arial" panose="020B0604020202020204" pitchFamily="34" charset="0"/>
                <a:cs typeface="Arial" panose="020B0604020202020204" pitchFamily="34" charset="0"/>
              </a:rPr>
              <a:t>Supplementary figure 4: RNA-seq reads in WWOX DELs. </a:t>
            </a:r>
          </a:p>
          <a:p>
            <a:r>
              <a:rPr lang="en-GB" sz="1100">
                <a:latin typeface="Arial" panose="020B0604020202020204" pitchFamily="34" charset="0"/>
                <a:cs typeface="Arial" panose="020B0604020202020204" pitchFamily="34" charset="0"/>
              </a:rPr>
              <a:t>Screenshot using Integrative Genomics Viewer (IGV), showing d</a:t>
            </a:r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etails of RNA-seq reads in the </a:t>
            </a:r>
            <a:r>
              <a:rPr lang="en-US" sz="1100" i="1">
                <a:latin typeface="Arial" panose="020B0604020202020204" pitchFamily="34" charset="0"/>
                <a:cs typeface="Arial" panose="020B0604020202020204" pitchFamily="34" charset="0"/>
              </a:rPr>
              <a:t>WWOX </a:t>
            </a:r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gene of a single sample. Left panel shows position of reads (grey) with horizontal lines indicating junction reads. Brackets indicate reads that span the junction caused by a DEL, indicated by the blue horizonal bar below. Right panel shows a split view of IGV, where several RNA-seq sequence reads (one is highlighted in light blue) match the location of the DEL that was identified on DNA (bottom dark blue bar). </a:t>
            </a:r>
          </a:p>
        </p:txBody>
      </p:sp>
    </p:spTree>
    <p:extLst>
      <p:ext uri="{BB962C8B-B14F-4D97-AF65-F5344CB8AC3E}">
        <p14:creationId xmlns:p14="http://schemas.microsoft.com/office/powerpoint/2010/main" val="392361299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8EB2D04-4520-48CC-AAA9-0EE62A9D4C6F}"/>
              </a:ext>
            </a:extLst>
          </p:cNvPr>
          <p:cNvSpPr txBox="1"/>
          <p:nvPr/>
        </p:nvSpPr>
        <p:spPr>
          <a:xfrm>
            <a:off x="955221" y="293914"/>
            <a:ext cx="86673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/>
              <a:t>Supplementary figure 5</a:t>
            </a:r>
            <a:endParaRPr lang="en-NL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2D0247F3-6520-463E-B4DD-04103E4CC73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241" y="1295272"/>
            <a:ext cx="9144000" cy="361797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095B8D8-E86E-477B-BC78-A5021AF7FBFF}"/>
              </a:ext>
            </a:extLst>
          </p:cNvPr>
          <p:cNvSpPr txBox="1"/>
          <p:nvPr/>
        </p:nvSpPr>
        <p:spPr>
          <a:xfrm>
            <a:off x="612322" y="5678353"/>
            <a:ext cx="9323615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>
                <a:latin typeface="Arial" panose="020B0604020202020204" pitchFamily="34" charset="0"/>
                <a:cs typeface="Arial" panose="020B0604020202020204" pitchFamily="34" charset="0"/>
              </a:rPr>
              <a:t>Supplementary figure 5: </a:t>
            </a:r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changepoints in nr DELs (10kb-1Mb) in the hotspot CFS regions</a:t>
            </a:r>
          </a:p>
          <a:p>
            <a:r>
              <a:rPr lang="en-GB" sz="1100">
                <a:latin typeface="Arial" panose="020B0604020202020204" pitchFamily="34" charset="0"/>
                <a:cs typeface="Arial" panose="020B0604020202020204" pitchFamily="34" charset="0"/>
              </a:rPr>
              <a:t>A regression model was fitted to the nr of DELs inside CFS regions, indicating 3 changepoints in the curve (indicated by the blue curves). The midpoint between the first two changepoints was selected to indicate samples with a high nr of DELs (&gt;20).</a:t>
            </a:r>
            <a:endParaRPr lang="en-NL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017698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31</TotalTime>
  <Words>348</Words>
  <Application>Microsoft Office PowerPoint</Application>
  <PresentationFormat>Widescreen</PresentationFormat>
  <Paragraphs>19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cel Smid</dc:creator>
  <cp:lastModifiedBy>Marcel Smid</cp:lastModifiedBy>
  <cp:revision>76</cp:revision>
  <dcterms:created xsi:type="dcterms:W3CDTF">2021-11-04T10:50:38Z</dcterms:created>
  <dcterms:modified xsi:type="dcterms:W3CDTF">2022-03-29T07:45:54Z</dcterms:modified>
</cp:coreProperties>
</file>